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796088" cy="98742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1F9F4A-2C18-4A3D-8190-723A13F9391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2067FC-2054-41B9-AB4B-FFEDB5CF77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99CE2F-A096-4173-891B-13056EEEC5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77FF0F-362C-4FCC-A1E9-BE55BE8885C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26D732-7128-4951-83AD-D4B643D07D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FDF590-75E6-470F-A8D0-3AF4BDE108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794413-E4FA-4172-9A08-4AFC64B1BB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EF4219-9F42-484D-9531-6033D0D36B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704996-9D1B-41F1-B4FF-FCA8C9C717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AE1B93-00C4-45FB-AA54-138706A035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77B30F-57FC-4A25-B006-3F924C1068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48E0C2-5AC1-42BD-9A8F-069B07749F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939CC9-C928-400D-B21A-3502450721A7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3070080" y="258840"/>
            <a:ext cx="250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upplementary Figure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hart 3" descr=""/>
          <p:cNvPicPr/>
          <p:nvPr/>
        </p:nvPicPr>
        <p:blipFill>
          <a:blip r:embed="rId1"/>
          <a:stretch/>
        </p:blipFill>
        <p:spPr>
          <a:xfrm>
            <a:off x="2114640" y="1407960"/>
            <a:ext cx="4914720" cy="2756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Chart 1" descr=""/>
          <p:cNvPicPr/>
          <p:nvPr/>
        </p:nvPicPr>
        <p:blipFill>
          <a:blip r:embed="rId1"/>
          <a:stretch/>
        </p:blipFill>
        <p:spPr>
          <a:xfrm>
            <a:off x="1901880" y="1481040"/>
            <a:ext cx="4584600" cy="2756160"/>
          </a:xfrm>
          <a:prstGeom prst="rect">
            <a:avLst/>
          </a:prstGeom>
          <a:ln w="0">
            <a:noFill/>
          </a:ln>
        </p:spPr>
      </p:pic>
      <p:sp>
        <p:nvSpPr>
          <p:cNvPr id="44" name="TextBox 2"/>
          <p:cNvSpPr/>
          <p:nvPr/>
        </p:nvSpPr>
        <p:spPr>
          <a:xfrm>
            <a:off x="3070080" y="76320"/>
            <a:ext cx="250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upplementary Figure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2" descr="Venn Diagram DOWN"/>
          <p:cNvPicPr/>
          <p:nvPr/>
        </p:nvPicPr>
        <p:blipFill>
          <a:blip r:embed="rId1"/>
          <a:srcRect l="0" t="11069" r="0" b="16412"/>
          <a:stretch/>
        </p:blipFill>
        <p:spPr>
          <a:xfrm>
            <a:off x="4689360" y="1916280"/>
            <a:ext cx="2448000" cy="177156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3" descr="Venn Diagram UP"/>
          <p:cNvPicPr/>
          <p:nvPr/>
        </p:nvPicPr>
        <p:blipFill>
          <a:blip r:embed="rId2"/>
          <a:srcRect l="0" t="11419" r="0" b="17716"/>
          <a:stretch/>
        </p:blipFill>
        <p:spPr>
          <a:xfrm>
            <a:off x="2050920" y="1916280"/>
            <a:ext cx="2419560" cy="1714320"/>
          </a:xfrm>
          <a:prstGeom prst="rect">
            <a:avLst/>
          </a:prstGeom>
          <a:ln w="0">
            <a:noFill/>
          </a:ln>
        </p:spPr>
      </p:pic>
      <p:sp>
        <p:nvSpPr>
          <p:cNvPr id="47" name="Text Box 2"/>
          <p:cNvSpPr/>
          <p:nvPr/>
        </p:nvSpPr>
        <p:spPr>
          <a:xfrm>
            <a:off x="2057400" y="1725480"/>
            <a:ext cx="299880" cy="261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  <a:ea typeface="Arial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 Box 2"/>
          <p:cNvSpPr/>
          <p:nvPr/>
        </p:nvSpPr>
        <p:spPr>
          <a:xfrm>
            <a:off x="4695840" y="1735200"/>
            <a:ext cx="290520" cy="261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6"/>
          <p:cNvSpPr/>
          <p:nvPr/>
        </p:nvSpPr>
        <p:spPr>
          <a:xfrm>
            <a:off x="2998080" y="187200"/>
            <a:ext cx="250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upplementary Figure S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1"/>
          <p:cNvSpPr/>
          <p:nvPr/>
        </p:nvSpPr>
        <p:spPr>
          <a:xfrm>
            <a:off x="5029200" y="3789360"/>
            <a:ext cx="4006800" cy="264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Healthy control- no known splicing mut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MDS-RARS-SF3B1 mutation  (K700E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53% C, 47% 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MDS-RARS-SF3B1 mutation (K700E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55% C, 45% 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MDS-RCMD- no known splicing gene mut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Picture 2" descr=""/>
          <p:cNvPicPr/>
          <p:nvPr/>
        </p:nvPicPr>
        <p:blipFill>
          <a:blip r:embed="rId1"/>
          <a:stretch/>
        </p:blipFill>
        <p:spPr>
          <a:xfrm>
            <a:off x="539640" y="3157560"/>
            <a:ext cx="4489560" cy="3502080"/>
          </a:xfrm>
          <a:prstGeom prst="rect">
            <a:avLst/>
          </a:prstGeom>
          <a:ln w="0">
            <a:noFill/>
          </a:ln>
        </p:spPr>
      </p:pic>
      <p:sp>
        <p:nvSpPr>
          <p:cNvPr id="52" name="Straight Connector 3"/>
          <p:cNvSpPr/>
          <p:nvPr/>
        </p:nvSpPr>
        <p:spPr>
          <a:xfrm>
            <a:off x="539640" y="4508640"/>
            <a:ext cx="46800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Straight Connector 4"/>
          <p:cNvSpPr/>
          <p:nvPr/>
        </p:nvSpPr>
        <p:spPr>
          <a:xfrm>
            <a:off x="539640" y="5111640"/>
            <a:ext cx="46800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Straight Connector 5"/>
          <p:cNvSpPr/>
          <p:nvPr/>
        </p:nvSpPr>
        <p:spPr>
          <a:xfrm>
            <a:off x="539640" y="5732640"/>
            <a:ext cx="46800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8"/>
          <p:cNvSpPr/>
          <p:nvPr/>
        </p:nvSpPr>
        <p:spPr>
          <a:xfrm>
            <a:off x="2767680" y="276120"/>
            <a:ext cx="250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Supplementary Figure S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6" name="Group 2"/>
          <p:cNvGrpSpPr/>
          <p:nvPr/>
        </p:nvGrpSpPr>
        <p:grpSpPr>
          <a:xfrm>
            <a:off x="6156360" y="728640"/>
            <a:ext cx="2152440" cy="2538360"/>
            <a:chOff x="6156360" y="728640"/>
            <a:chExt cx="2152440" cy="2538360"/>
          </a:xfrm>
        </p:grpSpPr>
        <p:pic>
          <p:nvPicPr>
            <p:cNvPr id="57" name="Picture 2" descr=""/>
            <p:cNvPicPr/>
            <p:nvPr/>
          </p:nvPicPr>
          <p:blipFill>
            <a:blip r:embed="rId2"/>
            <a:srcRect l="0" t="0" r="0" b="56578"/>
            <a:stretch/>
          </p:blipFill>
          <p:spPr>
            <a:xfrm>
              <a:off x="6156360" y="728640"/>
              <a:ext cx="2152440" cy="1080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Picture 3" descr=""/>
            <p:cNvPicPr/>
            <p:nvPr/>
          </p:nvPicPr>
          <p:blipFill>
            <a:blip r:embed="rId3"/>
            <a:srcRect l="19686" t="23383" r="5315" b="10882"/>
            <a:stretch/>
          </p:blipFill>
          <p:spPr>
            <a:xfrm>
              <a:off x="6175800" y="1809000"/>
              <a:ext cx="2124000" cy="145800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9" name="Text Box 2"/>
          <p:cNvSpPr/>
          <p:nvPr/>
        </p:nvSpPr>
        <p:spPr>
          <a:xfrm>
            <a:off x="5281560" y="873000"/>
            <a:ext cx="300240" cy="261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  <a:ea typeface="Arial"/>
              </a:rPr>
              <a:t>A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 Box 2"/>
          <p:cNvSpPr/>
          <p:nvPr/>
        </p:nvSpPr>
        <p:spPr>
          <a:xfrm>
            <a:off x="249120" y="2738520"/>
            <a:ext cx="290520" cy="2613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2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3-11T10:15:16Z</dcterms:created>
  <dc:creator>hd</dc:creator>
  <dc:description/>
  <dc:language>en-US</dc:language>
  <cp:lastModifiedBy>L.Latha</cp:lastModifiedBy>
  <cp:lastPrinted>2014-05-15T11:13:47Z</cp:lastPrinted>
  <dcterms:modified xsi:type="dcterms:W3CDTF">2014-12-17T05:23:42Z</dcterms:modified>
  <cp:revision>86</cp:revision>
  <dc:subject/>
  <dc:title>PowerPoint Presentation</dc:title>
</cp:coreProperties>
</file>